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93" r:id="rId2"/>
    <p:sldId id="283" r:id="rId3"/>
    <p:sldId id="294" r:id="rId4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nathan Aldridge" initials="JA" lastIdx="1" clrIdx="0">
    <p:extLst>
      <p:ext uri="{19B8F6BF-5375-455C-9EA6-DF929625EA0E}">
        <p15:presenceInfo xmlns:p15="http://schemas.microsoft.com/office/powerpoint/2012/main" userId="Jonathan Aldridg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7593" autoAdjust="0"/>
  </p:normalViewPr>
  <p:slideViewPr>
    <p:cSldViewPr>
      <p:cViewPr varScale="1">
        <p:scale>
          <a:sx n="87" d="100"/>
          <a:sy n="87" d="100"/>
        </p:scale>
        <p:origin x="2928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418" cy="512140"/>
          </a:xfrm>
          <a:prstGeom prst="rect">
            <a:avLst/>
          </a:prstGeom>
        </p:spPr>
        <p:txBody>
          <a:bodyPr vert="horz" lIns="94741" tIns="47370" rIns="94741" bIns="4737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24" y="0"/>
            <a:ext cx="3076418" cy="512140"/>
          </a:xfrm>
          <a:prstGeom prst="rect">
            <a:avLst/>
          </a:prstGeom>
        </p:spPr>
        <p:txBody>
          <a:bodyPr vert="horz" lIns="94741" tIns="47370" rIns="94741" bIns="47370" rtlCol="0"/>
          <a:lstStyle>
            <a:lvl1pPr algn="r">
              <a:defRPr sz="1200"/>
            </a:lvl1pPr>
          </a:lstStyle>
          <a:p>
            <a:fld id="{ECB499BA-B063-4BAB-A33D-7B75C6B54B42}" type="datetimeFigureOut">
              <a:rPr lang="en-US" smtClean="0"/>
              <a:t>5/2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66763"/>
            <a:ext cx="2879725" cy="3838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41" tIns="47370" rIns="94741" bIns="4737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433" y="4861237"/>
            <a:ext cx="5680435" cy="4605984"/>
          </a:xfrm>
          <a:prstGeom prst="rect">
            <a:avLst/>
          </a:prstGeom>
        </p:spPr>
        <p:txBody>
          <a:bodyPr vert="horz" lIns="94741" tIns="47370" rIns="94741" bIns="4737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0838"/>
            <a:ext cx="3076418" cy="512139"/>
          </a:xfrm>
          <a:prstGeom prst="rect">
            <a:avLst/>
          </a:prstGeom>
        </p:spPr>
        <p:txBody>
          <a:bodyPr vert="horz" lIns="94741" tIns="47370" rIns="94741" bIns="4737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24" y="9720838"/>
            <a:ext cx="3076418" cy="512139"/>
          </a:xfrm>
          <a:prstGeom prst="rect">
            <a:avLst/>
          </a:prstGeom>
        </p:spPr>
        <p:txBody>
          <a:bodyPr vert="horz" lIns="94741" tIns="47370" rIns="94741" bIns="47370" rtlCol="0" anchor="b"/>
          <a:lstStyle>
            <a:lvl1pPr algn="r">
              <a:defRPr sz="1200"/>
            </a:lvl1pPr>
          </a:lstStyle>
          <a:p>
            <a:fld id="{F759720E-3814-4790-9B9D-3196FDD762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923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B2542-1CF2-47FA-AE8E-F3D3F83CBB39}" type="datetime1">
              <a:rPr lang="en-US" smtClean="0"/>
              <a:t>5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363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2662-7CBF-4776-8681-107A43954819}" type="datetime1">
              <a:rPr lang="en-US" smtClean="0"/>
              <a:t>5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311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59C738-AAE1-412A-A1FC-662B28AA369F}" type="datetime1">
              <a:rPr lang="en-US" smtClean="0"/>
              <a:t>5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390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1D4972-B818-4E5F-BE67-07B460A377A7}" type="datetime1">
              <a:rPr lang="en-US" smtClean="0"/>
              <a:t>5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985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C0C6E-F741-4078-A35F-0FAF88E97D24}" type="datetime1">
              <a:rPr lang="en-US" smtClean="0"/>
              <a:t>5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051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F7490-1EC3-4550-8EE0-D4FF94FE5E7B}" type="datetime1">
              <a:rPr lang="en-US" smtClean="0"/>
              <a:t>5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648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CB61A-4A9E-4299-B6BA-D145502D3EC6}" type="datetime1">
              <a:rPr lang="en-US" smtClean="0"/>
              <a:t>5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837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3EA29-33A2-4372-B1C8-21ED045D9906}" type="datetime1">
              <a:rPr lang="en-US" smtClean="0"/>
              <a:t>5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925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CC875-9178-45AA-A204-428B1E638814}" type="datetime1">
              <a:rPr lang="en-US" smtClean="0"/>
              <a:t>5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840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F586-7748-4E2A-ACC9-C818FA47B00B}" type="datetime1">
              <a:rPr lang="en-US" smtClean="0"/>
              <a:t>5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195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CDCEA-0544-4872-A9DA-39587315FCC5}" type="datetime1">
              <a:rPr lang="en-US" smtClean="0"/>
              <a:t>5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411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48722F-EEFB-4E57-8034-65CE45E94350}" type="datetime1">
              <a:rPr lang="en-US" smtClean="0"/>
              <a:t>5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92D241-BE93-48A6-BCDB-B8BDA4A4EA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Additional file 1</a:t>
            </a:r>
            <a:endParaRPr lang="en-US" dirty="0"/>
          </a:p>
        </p:txBody>
      </p:sp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marL="0" indent="0" algn="just">
              <a:buNone/>
            </a:pPr>
            <a:r>
              <a:rPr lang="en-US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ains supplementary data to the following manuscript:</a:t>
            </a:r>
          </a:p>
          <a:p>
            <a:pPr marL="0" indent="0" algn="just">
              <a:buNone/>
            </a:pPr>
            <a:endParaRPr 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just">
              <a:buNone/>
            </a:pPr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x-based differences in association between circulating T cell subsets and disease activity in untreated early rheumatoid </a:t>
            </a:r>
            <a:r>
              <a:rPr lang="en-GB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thritis patients</a:t>
            </a:r>
          </a:p>
          <a:p>
            <a:pPr marL="0" indent="0" algn="just">
              <a:buNone/>
            </a:pP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marL="0" indent="0" algn="just">
              <a:buNone/>
            </a:pP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onathan Aldridge</a:t>
            </a:r>
            <a:r>
              <a:rPr lang="en-US" sz="15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5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yesh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Pandya, PhD</a:t>
            </a:r>
            <a:r>
              <a:rPr lang="en-US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inda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urs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D</a:t>
            </a:r>
            <a:r>
              <a:rPr lang="en-US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erstin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ersson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Sc</a:t>
            </a:r>
            <a:r>
              <a:rPr lang="en-US" sz="15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er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rdström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Sc</a:t>
            </a:r>
            <a:r>
              <a:rPr lang="en-US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lke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ander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D, 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D</a:t>
            </a:r>
            <a:r>
              <a:rPr lang="en-US" sz="15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5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na-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in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dell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D</a:t>
            </a:r>
            <a:r>
              <a:rPr lang="en-US" sz="15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Anna Rudin, MD, PhD</a:t>
            </a:r>
            <a:r>
              <a:rPr lang="en-US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just">
              <a:buNone/>
            </a:pPr>
            <a:r>
              <a:rPr lang="en-US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just">
              <a:buNone/>
            </a:pPr>
            <a:r>
              <a:rPr lang="en-US" sz="15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Rheumatology and Inflammation Research, Institute of Medicine, Sahlgrenska Academy of University of Gothenburg, Sweden.</a:t>
            </a:r>
          </a:p>
          <a:p>
            <a:pPr marL="0" indent="0" algn="just">
              <a:buNone/>
            </a:pPr>
            <a:r>
              <a:rPr lang="en-US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Rheumatology,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kåne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iversity Hospital Lund and Malmö, Lund University, Sweden.</a:t>
            </a:r>
          </a:p>
          <a:p>
            <a:pPr marL="0" indent="0" algn="just">
              <a:buNone/>
            </a:pP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marL="0" indent="0" algn="just">
              <a:buNone/>
            </a:pP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unning title: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 subsets and disease activity in early RA</a:t>
            </a:r>
            <a:r>
              <a:rPr lang="en-US" sz="15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1435342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7551" y="705945"/>
            <a:ext cx="3375001" cy="212500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1150063" y="3720270"/>
            <a:ext cx="4050001" cy="2550001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4931792" y="2034167"/>
            <a:ext cx="1008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2X = 0.36</a:t>
            </a:r>
          </a:p>
          <a:p>
            <a:r>
              <a:rPr lang="en-US" sz="1200" dirty="0" smtClean="0"/>
              <a:t>R2Y = 0.35</a:t>
            </a:r>
          </a:p>
          <a:p>
            <a:r>
              <a:rPr lang="en-US" sz="1200" dirty="0" smtClean="0"/>
              <a:t>Q2 = 0.20</a:t>
            </a:r>
            <a:endParaRPr lang="en-US" sz="1200" dirty="0"/>
          </a:p>
        </p:txBody>
      </p:sp>
      <p:grpSp>
        <p:nvGrpSpPr>
          <p:cNvPr id="31" name="Group 30"/>
          <p:cNvGrpSpPr/>
          <p:nvPr/>
        </p:nvGrpSpPr>
        <p:grpSpPr>
          <a:xfrm>
            <a:off x="4941168" y="797967"/>
            <a:ext cx="1053802" cy="461665"/>
            <a:chOff x="4941168" y="539552"/>
            <a:chExt cx="1053802" cy="461665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4"/>
            <a:srcRect l="40290" t="13160" r="55443" b="76674"/>
            <a:stretch/>
          </p:blipFill>
          <p:spPr>
            <a:xfrm>
              <a:off x="4941168" y="597556"/>
              <a:ext cx="144016" cy="216024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4"/>
            <a:srcRect l="72541" t="31435" r="23192" b="61788"/>
            <a:stretch/>
          </p:blipFill>
          <p:spPr>
            <a:xfrm>
              <a:off x="4950544" y="827583"/>
              <a:ext cx="144016" cy="144017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4986858" y="539552"/>
              <a:ext cx="100811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ueRA (n=72)</a:t>
              </a:r>
            </a:p>
            <a:p>
              <a:r>
                <a:rPr lang="en-US" sz="1200" dirty="0" smtClean="0"/>
                <a:t>HC (n=31)</a:t>
              </a:r>
              <a:endParaRPr lang="en-US" sz="1200" dirty="0"/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44624" y="9821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1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37280" y="7169512"/>
            <a:ext cx="653208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s in the proportions of T cell subsets between untreated early RA and health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variat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ctor analysis was performed to investigate differences in the proportions of T cell subsets betwee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(male + female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smtClean="0">
                <a:highlight>
                  <a:srgbClr val="FFFF00"/>
                </a:highlight>
                <a:latin typeface="Times New Roman" panose="02020603050405020304" pitchFamily="18" charset="0"/>
                <a:ea typeface="Calibri" panose="020F0502020204030204" pitchFamily="34" charset="0"/>
              </a:rPr>
              <a:t>n=7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early rheumatoid arthritis (ueRA)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lth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s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, ma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male, n= 31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LS-DA score scatter plot showing the separat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eR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HC based on T cell subsets proportion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PLS-DA column loading plot depicting the association betwee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eR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HC (Y-variables) and T cell subset proportions (X-variables). X-variables represented by bars pointing in the same direction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eR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positively associated, whereas variables in the opposite direction are inversely related t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eR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Asterisks  indicate significant difference  between ueRA and HC in Two-tail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n-Whitne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-test.  *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0.05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0.01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0.001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≤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01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24744" y="395536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124744" y="277180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915937" y="3610735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*</a:t>
            </a:r>
            <a:endParaRPr lang="en-US" sz="500" dirty="0"/>
          </a:p>
        </p:txBody>
      </p:sp>
      <p:sp>
        <p:nvSpPr>
          <p:cNvPr id="41" name="TextBox 40"/>
          <p:cNvSpPr txBox="1"/>
          <p:nvPr/>
        </p:nvSpPr>
        <p:spPr>
          <a:xfrm>
            <a:off x="3862744" y="3989726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***</a:t>
            </a:r>
            <a:endParaRPr lang="en-US" sz="500" dirty="0"/>
          </a:p>
        </p:txBody>
      </p:sp>
      <p:sp>
        <p:nvSpPr>
          <p:cNvPr id="42" name="TextBox 41"/>
          <p:cNvSpPr txBox="1"/>
          <p:nvPr/>
        </p:nvSpPr>
        <p:spPr>
          <a:xfrm>
            <a:off x="3888007" y="3803196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</a:t>
            </a:r>
            <a:endParaRPr lang="en-US" sz="500" dirty="0"/>
          </a:p>
        </p:txBody>
      </p:sp>
      <p:sp>
        <p:nvSpPr>
          <p:cNvPr id="50" name="TextBox 49"/>
          <p:cNvSpPr txBox="1"/>
          <p:nvPr/>
        </p:nvSpPr>
        <p:spPr>
          <a:xfrm>
            <a:off x="3679702" y="5755622"/>
            <a:ext cx="3973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*</a:t>
            </a:r>
            <a:endParaRPr lang="en-US" sz="500" dirty="0"/>
          </a:p>
        </p:txBody>
      </p:sp>
      <p:sp>
        <p:nvSpPr>
          <p:cNvPr id="51" name="TextBox 50"/>
          <p:cNvSpPr txBox="1"/>
          <p:nvPr/>
        </p:nvSpPr>
        <p:spPr>
          <a:xfrm>
            <a:off x="3684906" y="6142120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*</a:t>
            </a:r>
            <a:endParaRPr lang="en-US" sz="500" dirty="0"/>
          </a:p>
        </p:txBody>
      </p:sp>
      <p:sp>
        <p:nvSpPr>
          <p:cNvPr id="52" name="TextBox 51"/>
          <p:cNvSpPr txBox="1"/>
          <p:nvPr/>
        </p:nvSpPr>
        <p:spPr>
          <a:xfrm>
            <a:off x="3671430" y="6522193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*</a:t>
            </a:r>
            <a:endParaRPr lang="en-US" sz="500" dirty="0"/>
          </a:p>
        </p:txBody>
      </p:sp>
      <p:sp>
        <p:nvSpPr>
          <p:cNvPr id="53" name="TextBox 52"/>
          <p:cNvSpPr txBox="1"/>
          <p:nvPr/>
        </p:nvSpPr>
        <p:spPr>
          <a:xfrm>
            <a:off x="3682304" y="5946682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*</a:t>
            </a:r>
            <a:endParaRPr lang="en-US" sz="500" dirty="0"/>
          </a:p>
        </p:txBody>
      </p:sp>
      <p:sp>
        <p:nvSpPr>
          <p:cNvPr id="54" name="TextBox 53"/>
          <p:cNvSpPr txBox="1"/>
          <p:nvPr/>
        </p:nvSpPr>
        <p:spPr>
          <a:xfrm>
            <a:off x="3889999" y="4187306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</a:t>
            </a:r>
            <a:endParaRPr lang="en-US" sz="500" dirty="0"/>
          </a:p>
        </p:txBody>
      </p:sp>
      <p:sp>
        <p:nvSpPr>
          <p:cNvPr id="55" name="TextBox 54"/>
          <p:cNvSpPr txBox="1"/>
          <p:nvPr/>
        </p:nvSpPr>
        <p:spPr>
          <a:xfrm>
            <a:off x="3678168" y="6337558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</a:t>
            </a:r>
            <a:endParaRPr lang="en-US" sz="500" dirty="0"/>
          </a:p>
        </p:txBody>
      </p:sp>
      <p:sp>
        <p:nvSpPr>
          <p:cNvPr id="58" name="TextBox 57"/>
          <p:cNvSpPr txBox="1"/>
          <p:nvPr/>
        </p:nvSpPr>
        <p:spPr>
          <a:xfrm>
            <a:off x="2210872" y="3136766"/>
            <a:ext cx="86409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endParaRPr 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2570577" y="3144144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ueRA</a:t>
            </a:r>
            <a:endParaRPr lang="en-US" sz="1200" dirty="0"/>
          </a:p>
        </p:txBody>
      </p:sp>
      <p:sp>
        <p:nvSpPr>
          <p:cNvPr id="59" name="TextBox 58"/>
          <p:cNvSpPr txBox="1"/>
          <p:nvPr/>
        </p:nvSpPr>
        <p:spPr>
          <a:xfrm>
            <a:off x="2180802" y="6679393"/>
            <a:ext cx="86409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2570577" y="6649016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HC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3863313" y="4395614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</a:t>
            </a:r>
            <a:endParaRPr lang="en-US" sz="500" dirty="0"/>
          </a:p>
        </p:txBody>
      </p:sp>
      <p:sp>
        <p:nvSpPr>
          <p:cNvPr id="43" name="TextBox 42"/>
          <p:cNvSpPr txBox="1"/>
          <p:nvPr/>
        </p:nvSpPr>
        <p:spPr>
          <a:xfrm>
            <a:off x="3901972" y="3415297"/>
            <a:ext cx="5620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*</a:t>
            </a:r>
            <a:endParaRPr lang="en-US" sz="500" dirty="0"/>
          </a:p>
        </p:txBody>
      </p:sp>
    </p:spTree>
    <p:extLst>
      <p:ext uri="{BB962C8B-B14F-4D97-AF65-F5344CB8AC3E}">
        <p14:creationId xmlns:p14="http://schemas.microsoft.com/office/powerpoint/2010/main" val="332426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3449983"/>
              </p:ext>
            </p:extLst>
          </p:nvPr>
        </p:nvGraphicFramePr>
        <p:xfrm>
          <a:off x="693738" y="541338"/>
          <a:ext cx="5919787" cy="3146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Dokument" r:id="rId3" imgW="5959425" imgH="3168393" progId="Word.Document.12">
                  <p:embed/>
                </p:oleObj>
              </mc:Choice>
              <mc:Fallback>
                <p:oleObj name="Dokument" r:id="rId3" imgW="5959425" imgH="3168393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3738" y="541338"/>
                        <a:ext cx="5919787" cy="3146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87769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248</TotalTime>
  <Words>234</Words>
  <Application>Microsoft Office PowerPoint</Application>
  <PresentationFormat>On-screen Show (4:3)</PresentationFormat>
  <Paragraphs>33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Dokument</vt:lpstr>
      <vt:lpstr>Additional file 1</vt:lpstr>
      <vt:lpstr>PowerPoint Presentation</vt:lpstr>
      <vt:lpstr>PowerPoint Presentation</vt:lpstr>
    </vt:vector>
  </TitlesOfParts>
  <Company>Gothenburg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yesh</dc:creator>
  <cp:lastModifiedBy>Jonathan Aldridge</cp:lastModifiedBy>
  <cp:revision>2241</cp:revision>
  <cp:lastPrinted>2017-03-28T14:10:47Z</cp:lastPrinted>
  <dcterms:created xsi:type="dcterms:W3CDTF">2016-10-25T07:03:04Z</dcterms:created>
  <dcterms:modified xsi:type="dcterms:W3CDTF">2018-05-23T11:27:35Z</dcterms:modified>
</cp:coreProperties>
</file>